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12" r:id="rId2"/>
    <p:sldId id="32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59" d="100"/>
          <a:sy n="59" d="100"/>
        </p:scale>
        <p:origin x="868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8DB055-3582-429E-AF81-0C51B78360E7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98AB39-BE91-48A4-BCFC-91E4CC2F5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022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8817F8-8596-4EB3-B461-7EA549745031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1876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7A567F-6724-B95F-4807-D58F4CCD29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2AF8DCF-104F-6945-E779-0D732A4CDE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552EBB-213A-B24E-AADC-021DA9425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12DE93-9749-DDAB-535E-6B2632742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AA2B38-3B4C-C843-77ED-2DD36BE12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4340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A64119-D8C8-E59D-8FA5-287B203FA3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33BE706-AD9E-84D7-9C89-8275F42442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0E23BC-443D-B042-6D17-F425DE1DA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C8C793-B23A-437F-7790-FC7C1F203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E17162-222F-C405-6F17-637428CBA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4587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B16B123-619D-7403-4871-5DCE5A67A0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C17734-0811-2C41-7F69-CEE8B19399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7A95EE-1844-A158-C33A-FCE14DF30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73C0E1-E92D-9FA4-8713-B96A70C59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CAAB65-F9A1-5EDF-AF99-A60F34AC5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925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FB8893-5867-9B1F-3D74-18F1D64012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080750-7B3A-F228-EA27-B77D08F978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9BE2B1-5D99-B7D8-D94A-0AFB71A34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A59E89-02B4-4755-08E3-5B7E03610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21178E-80B3-8B3C-FC9C-457D510F3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8492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F121B8-F08C-5C6F-F208-86953A184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F9BC76-5DAE-EB56-C3BE-7429E991CE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185D36-D363-ECE1-FD42-8C14ADC18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D2A28E-D907-F3F0-4829-C39A06E5A1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8B8183-9951-76B3-C001-32ADAF407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44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8F82F9-E9B4-3D5D-4998-BC43BED540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82FB9A-0DA1-887F-647E-3DCF2B9651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7B826BA-2EAE-4FE8-ADD1-76E809101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E6B4E5D-7BEC-D356-0848-67FACE8FC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0AC08D-179D-5462-1622-A0F642FDA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77E1778-3C1A-9B67-013B-1C73DCB5E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6797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D2E699-1A21-27A1-0412-96BD8F5290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DB766F-03DA-570B-6D7A-F1B56E57AA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8F0368-BB15-F139-3CD1-EE4FB35320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A01AA63-897F-251B-EAB6-EEDF19CF6F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B35C668-F404-9B63-F8F6-1078172DF1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4D520AB-C071-DC1F-4B57-C9A0449DA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BDB3F2A-8C45-AD1B-CC4F-2F750A04C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C345C78-121D-BEE3-3723-1E7E41733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0294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EEBB1C-D93F-9C51-0986-7DE925BB5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D02B43C-C3E0-C9AA-D3E9-02664FB4C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2639392-8269-2C08-921B-A9AA0DE67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DE0EAD5-9ABE-57A2-8D9C-E0ECF97A6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38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26BE765-4F4F-D311-8219-50D7FEBF0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43250AD-8ACE-3CE6-6256-1E513C98A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D8C6BB2-FB2F-8537-D47D-9F72A072C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362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5DE915-A3ED-8E28-2756-11650F52B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CCF8F1-B4BD-24CC-DB57-816EE2A915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C2B76F5-D68D-D672-9A7B-B1EF95C781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BC6A93D-B325-310C-003F-4085A6DC0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6C9C60-0398-DF46-1C08-B07D459B2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0476EBE-F1A2-BFF4-CAD5-9CDC1A057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4047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29018D-361C-FE8D-D997-D391BB671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4779147-0C31-9510-E312-17945D1A3A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456DBF7-C252-82F7-A57B-4B20854538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4A3417-046B-9923-9977-5CBD5AA6B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651E374-CFB5-B4EA-C72B-EC79BED90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E4D6439-6135-D17E-C1CA-2547D988C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076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3943127-CE58-BBF8-4FBB-A3B52F7F4F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89B805-34EE-6216-B76D-329C612C16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0415A4-3DCF-CB40-FD3F-C2C299E55B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8DD214-E8AE-4FC5-8C38-C983FBBF7C58}" type="datetimeFigureOut">
              <a:rPr kumimoji="1" lang="ja-JP" altLang="en-US" smtClean="0"/>
              <a:t>2023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927A84-640F-F3F8-F34B-52E298C731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61002C-E2C9-E6A5-7674-6D64C4518D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B4FAB-12A8-4254-9C1F-DCD948291A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7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sv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矢印: 左右 23">
            <a:extLst>
              <a:ext uri="{FF2B5EF4-FFF2-40B4-BE49-F238E27FC236}">
                <a16:creationId xmlns:a16="http://schemas.microsoft.com/office/drawing/2014/main" id="{1B3F4E4B-2DDA-4A90-8713-419B4BABB764}"/>
              </a:ext>
            </a:extLst>
          </p:cNvPr>
          <p:cNvSpPr/>
          <p:nvPr/>
        </p:nvSpPr>
        <p:spPr>
          <a:xfrm>
            <a:off x="1918633" y="2218869"/>
            <a:ext cx="2367280" cy="588597"/>
          </a:xfrm>
          <a:prstGeom prst="leftRightArrow">
            <a:avLst>
              <a:gd name="adj1" fmla="val 36238"/>
              <a:gd name="adj2" fmla="val 72018"/>
            </a:avLst>
          </a:prstGeom>
          <a:solidFill>
            <a:srgbClr val="52739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399F910-66B8-42B4-B142-9A882B5E3E4F}"/>
              </a:ext>
            </a:extLst>
          </p:cNvPr>
          <p:cNvSpPr txBox="1"/>
          <p:nvPr/>
        </p:nvSpPr>
        <p:spPr>
          <a:xfrm>
            <a:off x="1463706" y="867971"/>
            <a:ext cx="2801732" cy="523220"/>
          </a:xfrm>
          <a:prstGeom prst="rect">
            <a:avLst/>
          </a:prstGeom>
          <a:solidFill>
            <a:srgbClr val="52739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gistered Diagnosis of breast, colorectal or stomach cancer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矢印: 右 2">
            <a:extLst>
              <a:ext uri="{FF2B5EF4-FFF2-40B4-BE49-F238E27FC236}">
                <a16:creationId xmlns:a16="http://schemas.microsoft.com/office/drawing/2014/main" id="{28BBAFA3-90B5-453F-9803-6FFE783149F3}"/>
              </a:ext>
            </a:extLst>
          </p:cNvPr>
          <p:cNvSpPr/>
          <p:nvPr/>
        </p:nvSpPr>
        <p:spPr>
          <a:xfrm>
            <a:off x="4533538" y="2091878"/>
            <a:ext cx="6055387" cy="843280"/>
          </a:xfrm>
          <a:prstGeom prst="rightArrow">
            <a:avLst/>
          </a:prstGeom>
          <a:gradFill flip="none" rotWithShape="1">
            <a:gsLst>
              <a:gs pos="49000">
                <a:srgbClr val="527391"/>
              </a:gs>
              <a:gs pos="0">
                <a:schemeClr val="accent1">
                  <a:lumMod val="40000"/>
                  <a:lumOff val="60000"/>
                </a:schemeClr>
              </a:gs>
              <a:gs pos="89000">
                <a:srgbClr val="52739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矢印: 右 6">
            <a:extLst>
              <a:ext uri="{FF2B5EF4-FFF2-40B4-BE49-F238E27FC236}">
                <a16:creationId xmlns:a16="http://schemas.microsoft.com/office/drawing/2014/main" id="{3B102169-0E89-41AB-B268-22A8059A7A01}"/>
              </a:ext>
            </a:extLst>
          </p:cNvPr>
          <p:cNvSpPr/>
          <p:nvPr/>
        </p:nvSpPr>
        <p:spPr>
          <a:xfrm rot="16200000">
            <a:off x="1687917" y="3127290"/>
            <a:ext cx="461433" cy="3699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矢印: 右 7">
            <a:extLst>
              <a:ext uri="{FF2B5EF4-FFF2-40B4-BE49-F238E27FC236}">
                <a16:creationId xmlns:a16="http://schemas.microsoft.com/office/drawing/2014/main" id="{28AC9567-3C72-467D-9D89-D02C23EA0FB2}"/>
              </a:ext>
            </a:extLst>
          </p:cNvPr>
          <p:cNvSpPr/>
          <p:nvPr/>
        </p:nvSpPr>
        <p:spPr>
          <a:xfrm rot="16200000">
            <a:off x="4023632" y="3127290"/>
            <a:ext cx="461433" cy="3699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55DE679-4F5F-4B73-A78E-27C38B8888CF}"/>
              </a:ext>
            </a:extLst>
          </p:cNvPr>
          <p:cNvSpPr txBox="1"/>
          <p:nvPr/>
        </p:nvSpPr>
        <p:spPr>
          <a:xfrm>
            <a:off x="4579470" y="2349470"/>
            <a:ext cx="18880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servation Period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617DECE-8115-4427-8500-C5209685AA35}"/>
              </a:ext>
            </a:extLst>
          </p:cNvPr>
          <p:cNvSpPr txBox="1"/>
          <p:nvPr/>
        </p:nvSpPr>
        <p:spPr>
          <a:xfrm>
            <a:off x="2286509" y="2359630"/>
            <a:ext cx="163152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ok-Back Period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1AFB7FD-974F-426A-BACA-E5DDE0964FCB}"/>
              </a:ext>
            </a:extLst>
          </p:cNvPr>
          <p:cNvSpPr txBox="1"/>
          <p:nvPr/>
        </p:nvSpPr>
        <p:spPr>
          <a:xfrm>
            <a:off x="3144707" y="3587601"/>
            <a:ext cx="22192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 Check-Up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4035252-E4F3-4CB9-B522-C4F26F4EF4A6}"/>
              </a:ext>
            </a:extLst>
          </p:cNvPr>
          <p:cNvSpPr txBox="1"/>
          <p:nvPr/>
        </p:nvSpPr>
        <p:spPr>
          <a:xfrm>
            <a:off x="2415585" y="2642355"/>
            <a:ext cx="1614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 least 1 year)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5" name="図 54">
            <a:extLst>
              <a:ext uri="{FF2B5EF4-FFF2-40B4-BE49-F238E27FC236}">
                <a16:creationId xmlns:a16="http://schemas.microsoft.com/office/drawing/2014/main" id="{F784BE9E-FF8C-452C-B02C-68D43BA6C1A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75" t="8921" r="10541" b="15706"/>
          <a:stretch/>
        </p:blipFill>
        <p:spPr>
          <a:xfrm>
            <a:off x="3975159" y="3999113"/>
            <a:ext cx="558379" cy="532170"/>
          </a:xfrm>
          <a:prstGeom prst="rect">
            <a:avLst/>
          </a:prstGeom>
        </p:spPr>
      </p:pic>
      <p:pic>
        <p:nvPicPr>
          <p:cNvPr id="58" name="グラフィックス 57" descr="グループ">
            <a:extLst>
              <a:ext uri="{FF2B5EF4-FFF2-40B4-BE49-F238E27FC236}">
                <a16:creationId xmlns:a16="http://schemas.microsoft.com/office/drawing/2014/main" id="{26CE258B-8158-43E0-9AFF-BFE5F4D1EFD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l="7122" t="17520" r="4218" b="21539"/>
          <a:stretch/>
        </p:blipFill>
        <p:spPr>
          <a:xfrm flipH="1">
            <a:off x="4285913" y="1497093"/>
            <a:ext cx="1038286" cy="713655"/>
          </a:xfrm>
          <a:prstGeom prst="rect">
            <a:avLst/>
          </a:prstGeom>
        </p:spPr>
      </p:pic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D7BEEE2D-04D3-4B6B-A0D3-D79ECB8242AF}"/>
              </a:ext>
            </a:extLst>
          </p:cNvPr>
          <p:cNvSpPr txBox="1"/>
          <p:nvPr/>
        </p:nvSpPr>
        <p:spPr>
          <a:xfrm>
            <a:off x="1608142" y="3587602"/>
            <a:ext cx="161488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urance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erage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グラフィックス 27" descr="グループ">
            <a:extLst>
              <a:ext uri="{FF2B5EF4-FFF2-40B4-BE49-F238E27FC236}">
                <a16:creationId xmlns:a16="http://schemas.microsoft.com/office/drawing/2014/main" id="{74D80B6B-3B3B-433F-9F8E-D51F345C7EA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l="7122" t="17520" r="4218" b="21539"/>
          <a:stretch/>
        </p:blipFill>
        <p:spPr>
          <a:xfrm flipH="1">
            <a:off x="3303396" y="1497093"/>
            <a:ext cx="1038286" cy="713655"/>
          </a:xfrm>
          <a:prstGeom prst="rect">
            <a:avLst/>
          </a:prstGeom>
        </p:spPr>
      </p:pic>
      <p:sp>
        <p:nvSpPr>
          <p:cNvPr id="37" name="矢印: 右 36">
            <a:extLst>
              <a:ext uri="{FF2B5EF4-FFF2-40B4-BE49-F238E27FC236}">
                <a16:creationId xmlns:a16="http://schemas.microsoft.com/office/drawing/2014/main" id="{93A1048B-88AB-4515-AA7B-6B4013ED8F5B}"/>
              </a:ext>
            </a:extLst>
          </p:cNvPr>
          <p:cNvSpPr/>
          <p:nvPr/>
        </p:nvSpPr>
        <p:spPr>
          <a:xfrm rot="5400000">
            <a:off x="2624324" y="1543256"/>
            <a:ext cx="461433" cy="3699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07C9488-EEBA-4746-90AC-4A13413C7AB0}"/>
              </a:ext>
            </a:extLst>
          </p:cNvPr>
          <p:cNvSpPr txBox="1"/>
          <p:nvPr/>
        </p:nvSpPr>
        <p:spPr>
          <a:xfrm>
            <a:off x="2978455" y="4668252"/>
            <a:ext cx="2908778" cy="307777"/>
          </a:xfrm>
          <a:prstGeom prst="rect">
            <a:avLst/>
          </a:prstGeom>
          <a:solidFill>
            <a:srgbClr val="527391"/>
          </a:solidFill>
        </p:spPr>
        <p:txBody>
          <a:bodyPr wrap="square" anchor="ctr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Metabolic Syndrome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15BE12A-E527-C148-14FE-E37ABFF86BF4}"/>
              </a:ext>
            </a:extLst>
          </p:cNvPr>
          <p:cNvSpPr txBox="1"/>
          <p:nvPr/>
        </p:nvSpPr>
        <p:spPr>
          <a:xfrm>
            <a:off x="213646" y="134243"/>
            <a:ext cx="8665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Study Design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9F48F21-65EA-794A-AD6F-2FCBA377390D}"/>
              </a:ext>
            </a:extLst>
          </p:cNvPr>
          <p:cNvSpPr txBox="1"/>
          <p:nvPr/>
        </p:nvSpPr>
        <p:spPr>
          <a:xfrm>
            <a:off x="7878719" y="3039828"/>
            <a:ext cx="2680390" cy="1569660"/>
          </a:xfrm>
          <a:prstGeom prst="rect">
            <a:avLst/>
          </a:prstGeom>
          <a:noFill/>
          <a:ln w="19050">
            <a:solidFill>
              <a:srgbClr val="52739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al Endpoint 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ary Outcome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Myocardial Infarction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Angina Pectoris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Stroke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Heat Failure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77387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8827D3B-7D48-8C15-E0D8-DF33916B79D1}"/>
              </a:ext>
            </a:extLst>
          </p:cNvPr>
          <p:cNvSpPr txBox="1"/>
          <p:nvPr/>
        </p:nvSpPr>
        <p:spPr>
          <a:xfrm>
            <a:off x="213646" y="134243"/>
            <a:ext cx="8665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Flowchart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7DA5AA3-5968-CB12-B5FD-8C5DE8D08931}"/>
              </a:ext>
            </a:extLst>
          </p:cNvPr>
          <p:cNvSpPr txBox="1"/>
          <p:nvPr/>
        </p:nvSpPr>
        <p:spPr>
          <a:xfrm>
            <a:off x="160424" y="739436"/>
            <a:ext cx="10862479" cy="923330"/>
          </a:xfrm>
          <a:prstGeom prst="rect">
            <a:avLst/>
          </a:prstGeom>
          <a:ln w="285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 algn="ctr">
              <a:defRPr/>
            </a:pP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viduals diagnosed with breast, colorectal, or stomach cancer and undergoing health check-ups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vailable data for the assessment of the presence of metabolic syndrome</a:t>
            </a:r>
            <a:r>
              <a:rPr lang="ja-JP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the JMDC Claims database</a:t>
            </a:r>
          </a:p>
          <a:p>
            <a:pPr lvl="0" algn="ctr">
              <a:defRPr/>
            </a:pP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67,480)</a:t>
            </a:r>
            <a:endParaRPr lang="en-US" altLang="ja-JP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600F11B-4EF1-35CE-88E9-14FBBC9357DF}"/>
              </a:ext>
            </a:extLst>
          </p:cNvPr>
          <p:cNvSpPr txBox="1"/>
          <p:nvPr/>
        </p:nvSpPr>
        <p:spPr>
          <a:xfrm>
            <a:off x="2537865" y="5974416"/>
            <a:ext cx="5242560" cy="646331"/>
          </a:xfrm>
          <a:prstGeom prst="rect">
            <a:avLst/>
          </a:prstGeom>
          <a:ln w="285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in this study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53,510)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BB120DC1-48D3-E146-3AA4-788A8AD11597}"/>
              </a:ext>
            </a:extLst>
          </p:cNvPr>
          <p:cNvCxnSpPr>
            <a:cxnSpLocks/>
            <a:endCxn id="3" idx="0"/>
          </p:cNvCxnSpPr>
          <p:nvPr/>
        </p:nvCxnSpPr>
        <p:spPr>
          <a:xfrm flipH="1">
            <a:off x="5159145" y="1662766"/>
            <a:ext cx="30465" cy="431165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F6D2E56-50B2-569F-4C4F-0F95D6FA1AB8}"/>
              </a:ext>
            </a:extLst>
          </p:cNvPr>
          <p:cNvSpPr txBox="1"/>
          <p:nvPr/>
        </p:nvSpPr>
        <p:spPr>
          <a:xfrm>
            <a:off x="5947899" y="2941428"/>
            <a:ext cx="5980542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or history of renal replacement therapy (n=48)</a:t>
            </a: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7B1E63EF-7A11-8B2C-3635-289182D1068C}"/>
              </a:ext>
            </a:extLst>
          </p:cNvPr>
          <p:cNvCxnSpPr/>
          <p:nvPr/>
        </p:nvCxnSpPr>
        <p:spPr>
          <a:xfrm>
            <a:off x="5175433" y="3128884"/>
            <a:ext cx="741871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34A3A0B-B88E-15B7-F7C4-14C10033D124}"/>
              </a:ext>
            </a:extLst>
          </p:cNvPr>
          <p:cNvSpPr txBox="1"/>
          <p:nvPr/>
        </p:nvSpPr>
        <p:spPr>
          <a:xfrm>
            <a:off x="5962076" y="2182025"/>
            <a:ext cx="5980541" cy="369332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or history of cardiovascular disease (n=5,482)  </a:t>
            </a: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5C3FAF1D-7661-09A8-35FE-2FD0FF306B84}"/>
              </a:ext>
            </a:extLst>
          </p:cNvPr>
          <p:cNvCxnSpPr/>
          <p:nvPr/>
        </p:nvCxnSpPr>
        <p:spPr>
          <a:xfrm>
            <a:off x="5189610" y="2387037"/>
            <a:ext cx="741871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D8ED92D-0448-6344-6235-CDC2908DE4E0}"/>
              </a:ext>
            </a:extLst>
          </p:cNvPr>
          <p:cNvSpPr txBox="1"/>
          <p:nvPr/>
        </p:nvSpPr>
        <p:spPr>
          <a:xfrm>
            <a:off x="5962075" y="3700831"/>
            <a:ext cx="5980542" cy="1754326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on </a:t>
            </a:r>
          </a:p>
          <a:p>
            <a:pPr lvl="0">
              <a:defRPr/>
            </a:pPr>
            <a:r>
              <a:rPr lang="ja-JP" alt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ody mass index (n=11)</a:t>
            </a:r>
          </a:p>
          <a:p>
            <a:pPr lvl="0">
              <a:defRPr/>
            </a:pPr>
            <a:r>
              <a:rPr lang="ja-JP" alt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-density lipoprotein cholesterol (n=15)</a:t>
            </a:r>
            <a:r>
              <a:rPr lang="ja-JP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>
              <a:defRPr/>
            </a:pPr>
            <a:r>
              <a:rPr lang="ja-JP" alt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cohol consumption (n=6,535)</a:t>
            </a:r>
          </a:p>
          <a:p>
            <a:pPr lvl="0">
              <a:defRPr/>
            </a:pPr>
            <a:r>
              <a:rPr lang="ja-JP" alt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garette smoking (n=7)</a:t>
            </a:r>
          </a:p>
          <a:p>
            <a:pPr lvl="0">
              <a:defRPr/>
            </a:pPr>
            <a:r>
              <a:rPr lang="ja-JP" altLang="en-US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ysical activity (n=1,872)</a:t>
            </a: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4F617AAF-FABC-6BD3-2A57-FBB81DB5FD39}"/>
              </a:ext>
            </a:extLst>
          </p:cNvPr>
          <p:cNvCxnSpPr/>
          <p:nvPr/>
        </p:nvCxnSpPr>
        <p:spPr>
          <a:xfrm>
            <a:off x="5189609" y="4577994"/>
            <a:ext cx="741871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27311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5</Words>
  <Application>Microsoft Office PowerPoint</Application>
  <PresentationFormat>ワイド画面</PresentationFormat>
  <Paragraphs>29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Wingdings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子 英弘</dc:creator>
  <cp:lastModifiedBy>金子 英弘</cp:lastModifiedBy>
  <cp:revision>6</cp:revision>
  <dcterms:created xsi:type="dcterms:W3CDTF">2022-09-21T07:33:37Z</dcterms:created>
  <dcterms:modified xsi:type="dcterms:W3CDTF">2023-02-22T01:52:46Z</dcterms:modified>
</cp:coreProperties>
</file>